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7.jpeg" ContentType="image/jpeg"/>
  <Override PartName="/ppt/media/image11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A6D00-F6ED-48D4-AD75-D4C7E8F62D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C2059-9CB6-450D-ADB6-B9B4C7C762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34211-AE86-403F-8EF8-7D765430D2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2E8DB-DF9B-4A64-B4E6-B2F9DCE662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BDF0C-0FD1-489C-A66C-740757EA16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8A17A-6698-41A3-9C08-13EE97BC7F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07CF4-E5A6-43CC-BD25-DFAEA1E75D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74808-C09B-404F-B2F0-E69FACA79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6C245-79B9-4B72-9407-772383964E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D1EB9-AEE4-447E-A4EC-5F3AE9C789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BF5BC-EB69-41C0-9343-601456A644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C4CA7-E223-400C-8661-862D91895F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E51ACD-7C5A-44A3-8320-7584CFE1911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5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6.png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6669" r="0" b="6669"/>
          <a:stretch/>
        </p:blipFill>
        <p:spPr>
          <a:xfrm>
            <a:off x="533520" y="914400"/>
            <a:ext cx="8076960" cy="52498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57200" y="274680"/>
            <a:ext cx="822960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Exercise goal setting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0" t="9061" r="0" b="10681"/>
          <a:stretch/>
        </p:blipFill>
        <p:spPr>
          <a:xfrm>
            <a:off x="685800" y="1066680"/>
            <a:ext cx="7848720" cy="50292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57200" y="274680"/>
            <a:ext cx="822960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abular exercise summary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0" y="21430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0" y="21430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0" y="21718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0" y="22575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685800" y="838080"/>
            <a:ext cx="7238880" cy="5333760"/>
            <a:chOff x="685800" y="838080"/>
            <a:chExt cx="7238880" cy="5333760"/>
          </a:xfrm>
        </p:grpSpPr>
        <p:graphicFrame>
          <p:nvGraphicFramePr>
            <p:cNvPr id="50" name=""/>
            <p:cNvGraphicFramePr/>
            <p:nvPr/>
          </p:nvGraphicFramePr>
          <p:xfrm>
            <a:off x="685800" y="838080"/>
            <a:ext cx="3257280" cy="23338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685800" y="838080"/>
                      <a:ext cx="3257280" cy="2333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2" name=""/>
            <p:cNvGraphicFramePr/>
            <p:nvPr/>
          </p:nvGraphicFramePr>
          <p:xfrm>
            <a:off x="2567520" y="1045440"/>
            <a:ext cx="3257280" cy="23338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3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567520" y="1045440"/>
                      <a:ext cx="3257280" cy="2333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4" name=""/>
            <p:cNvGraphicFramePr/>
            <p:nvPr/>
          </p:nvGraphicFramePr>
          <p:xfrm>
            <a:off x="4739400" y="1321920"/>
            <a:ext cx="3185280" cy="22824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5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739400" y="1321920"/>
                      <a:ext cx="3185280" cy="2282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6" name=""/>
            <p:cNvGraphicFramePr/>
            <p:nvPr/>
          </p:nvGraphicFramePr>
          <p:xfrm>
            <a:off x="685800" y="3466080"/>
            <a:ext cx="2967480" cy="212688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57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685800" y="3466080"/>
                      <a:ext cx="2967480" cy="2126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58" name="" descr=""/>
            <p:cNvPicPr/>
            <p:nvPr/>
          </p:nvPicPr>
          <p:blipFill>
            <a:blip r:embed="rId9"/>
            <a:stretch/>
          </p:blipFill>
          <p:spPr>
            <a:xfrm>
              <a:off x="2567520" y="3881160"/>
              <a:ext cx="2895480" cy="208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" descr=""/>
            <p:cNvPicPr/>
            <p:nvPr/>
          </p:nvPicPr>
          <p:blipFill>
            <a:blip r:embed="rId10"/>
            <a:stretch/>
          </p:blipFill>
          <p:spPr>
            <a:xfrm>
              <a:off x="5028840" y="4088520"/>
              <a:ext cx="2895480" cy="2083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0" name=""/>
          <p:cNvSpPr/>
          <p:nvPr/>
        </p:nvSpPr>
        <p:spPr>
          <a:xfrm>
            <a:off x="457200" y="274680"/>
            <a:ext cx="822960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PDA exercise and symptom querie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rcRect l="0" t="10257" r="0" b="7693"/>
          <a:stretch/>
        </p:blipFill>
        <p:spPr>
          <a:xfrm>
            <a:off x="762120" y="1219320"/>
            <a:ext cx="7924680" cy="487656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228600" y="274680"/>
            <a:ext cx="868680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Graphical summary of exercise &amp; dyspnea rating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838080" y="990720"/>
            <a:ext cx="7315200" cy="5257800"/>
          </a:xfrm>
          <a:prstGeom prst="rect">
            <a:avLst/>
          </a:prstGeom>
          <a:ln w="0">
            <a:noFill/>
          </a:ln>
        </p:spPr>
      </p:pic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Dyspnea management learning module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990720" y="914400"/>
            <a:ext cx="7162560" cy="5334120"/>
          </a:xfrm>
          <a:prstGeom prst="rect">
            <a:avLst/>
          </a:prstGeom>
          <a:ln w="0">
            <a:noFill/>
          </a:ln>
        </p:spPr>
      </p:pic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56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ample module on breathing strategie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Dyspnea Self-Management Study</a:t>
            </a: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5-19T00:07:40Z</dcterms:created>
  <dc:creator>Huong Q. Nguyen</dc:creator>
  <dc:description/>
  <dc:language>en-US</dc:language>
  <cp:lastModifiedBy>hqn</cp:lastModifiedBy>
  <dcterms:modified xsi:type="dcterms:W3CDTF">2008-02-15T18:40:18Z</dcterms:modified>
  <cp:revision>25</cp:revision>
  <dc:subject/>
  <dc:title>Slide 1</dc:title>
</cp:coreProperties>
</file>